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H" initials="AH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8754" autoAdjust="0"/>
  </p:normalViewPr>
  <p:slideViewPr>
    <p:cSldViewPr>
      <p:cViewPr varScale="1">
        <p:scale>
          <a:sx n="86" d="100"/>
          <a:sy n="86" d="100"/>
        </p:scale>
        <p:origin x="562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zutoshi Fujibayashi" userId="35483d803165e713" providerId="LiveId" clId="{4620A09C-7B53-46F5-9757-D166F1C5E56A}"/>
    <pc:docChg chg="delSld">
      <pc:chgData name="Kazutoshi Fujibayashi" userId="35483d803165e713" providerId="LiveId" clId="{4620A09C-7B53-46F5-9757-D166F1C5E56A}" dt="2018-04-08T00:27:15.411" v="0" actId="2696"/>
      <pc:docMkLst>
        <pc:docMk/>
      </pc:docMkLst>
    </pc:docChg>
  </pc:docChgLst>
  <pc:docChgLst>
    <pc:chgData name="Fujibayashi Kazutoshi" userId="35483d803165e713" providerId="LiveId" clId="{F055B602-0C50-4DE1-A33D-44EF4BBACA44}"/>
    <pc:docChg chg="modSld">
      <pc:chgData name="Fujibayashi Kazutoshi" userId="35483d803165e713" providerId="LiveId" clId="{F055B602-0C50-4DE1-A33D-44EF4BBACA44}" dt="2018-04-15T01:05:39.433" v="1" actId="1037"/>
      <pc:docMkLst>
        <pc:docMk/>
      </pc:docMkLst>
      <pc:sldChg chg="modSp">
        <pc:chgData name="Fujibayashi Kazutoshi" userId="35483d803165e713" providerId="LiveId" clId="{F055B602-0C50-4DE1-A33D-44EF4BBACA44}" dt="2018-04-15T01:05:39.433" v="1" actId="1037"/>
        <pc:sldMkLst>
          <pc:docMk/>
          <pc:sldMk cId="1088169696" sldId="269"/>
        </pc:sldMkLst>
        <pc:spChg chg="mod">
          <ac:chgData name="Fujibayashi Kazutoshi" userId="35483d803165e713" providerId="LiveId" clId="{F055B602-0C50-4DE1-A33D-44EF4BBACA44}" dt="2018-04-15T01:05:39.433" v="1" actId="1037"/>
          <ac:spMkLst>
            <pc:docMk/>
            <pc:sldMk cId="1088169696" sldId="269"/>
            <ac:spMk id="3" creationId="{0177A75F-67B2-4593-85DC-C078C5DDB31A}"/>
          </ac:spMkLst>
        </pc:spChg>
      </pc:sldChg>
    </pc:docChg>
  </pc:docChgLst>
  <pc:docChgLst>
    <pc:chgData name="Kazutoshi Fujibayashi" userId="35483d803165e713" providerId="LiveId" clId="{F055B602-0C50-4DE1-A33D-44EF4BBACA44}"/>
    <pc:docChg chg="modSld">
      <pc:chgData name="Kazutoshi Fujibayashi" userId="35483d803165e713" providerId="LiveId" clId="{F055B602-0C50-4DE1-A33D-44EF4BBACA44}" dt="2018-04-08T05:21:53.346" v="0" actId="1038"/>
      <pc:docMkLst>
        <pc:docMk/>
      </pc:docMkLst>
      <pc:sldChg chg="modSp">
        <pc:chgData name="Kazutoshi Fujibayashi" userId="35483d803165e713" providerId="LiveId" clId="{F055B602-0C50-4DE1-A33D-44EF4BBACA44}" dt="2018-04-08T05:21:53.346" v="0" actId="1038"/>
        <pc:sldMkLst>
          <pc:docMk/>
          <pc:sldMk cId="1088169696" sldId="269"/>
        </pc:sldMkLst>
        <pc:spChg chg="mod">
          <ac:chgData name="Kazutoshi Fujibayashi" userId="35483d803165e713" providerId="LiveId" clId="{F055B602-0C50-4DE1-A33D-44EF4BBACA44}" dt="2018-04-08T05:21:53.346" v="0" actId="1038"/>
          <ac:spMkLst>
            <pc:docMk/>
            <pc:sldMk cId="1088169696" sldId="269"/>
            <ac:spMk id="3" creationId="{0177A75F-67B2-4593-85DC-C078C5DDB31A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Revise用データまとめ.xlsx]FluReportと薬剤処方情報分布比較!$M$1</c:f>
              <c:strCache>
                <c:ptCount val="1"/>
                <c:pt idx="0">
                  <c:v>Real-time prescription surveillanc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[Revise用データまとめ.xlsx]FluReportと薬剤処方情報分布比較!$L$2:$L$6</c:f>
              <c:strCache>
                <c:ptCount val="5"/>
                <c:pt idx="0">
                  <c:v>First period</c:v>
                </c:pt>
                <c:pt idx="1">
                  <c:v>Second period</c:v>
                </c:pt>
                <c:pt idx="2">
                  <c:v>Third period</c:v>
                </c:pt>
                <c:pt idx="3">
                  <c:v>Fourth period</c:v>
                </c:pt>
                <c:pt idx="4">
                  <c:v>Fifth period</c:v>
                </c:pt>
              </c:strCache>
            </c:strRef>
          </c:cat>
          <c:val>
            <c:numRef>
              <c:f>[Revise用データまとめ.xlsx]FluReportと薬剤処方情報分布比較!$M$2:$M$6</c:f>
              <c:numCache>
                <c:formatCode>0.0</c:formatCode>
                <c:ptCount val="5"/>
                <c:pt idx="0">
                  <c:v>1.6938607658847959</c:v>
                </c:pt>
                <c:pt idx="1">
                  <c:v>7.3812217425910074</c:v>
                </c:pt>
                <c:pt idx="2">
                  <c:v>22.592548056057502</c:v>
                </c:pt>
                <c:pt idx="3">
                  <c:v>52.20893488331383</c:v>
                </c:pt>
                <c:pt idx="4">
                  <c:v>16.1234345521528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62-4EDD-BF2B-4051065EB314}"/>
            </c:ext>
          </c:extLst>
        </c:ser>
        <c:ser>
          <c:idx val="1"/>
          <c:order val="1"/>
          <c:tx>
            <c:strRef>
              <c:f>[Revise用データまとめ.xlsx]FluReportと薬剤処方情報分布比較!$N$1</c:f>
              <c:strCache>
                <c:ptCount val="1"/>
                <c:pt idx="0">
                  <c:v>Flu Repor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[Revise用データまとめ.xlsx]FluReportと薬剤処方情報分布比較!$L$2:$L$6</c:f>
              <c:strCache>
                <c:ptCount val="5"/>
                <c:pt idx="0">
                  <c:v>First period</c:v>
                </c:pt>
                <c:pt idx="1">
                  <c:v>Second period</c:v>
                </c:pt>
                <c:pt idx="2">
                  <c:v>Third period</c:v>
                </c:pt>
                <c:pt idx="3">
                  <c:v>Fourth period</c:v>
                </c:pt>
                <c:pt idx="4">
                  <c:v>Fifth period</c:v>
                </c:pt>
              </c:strCache>
            </c:strRef>
          </c:cat>
          <c:val>
            <c:numRef>
              <c:f>[Revise用データまとめ.xlsx]FluReportと薬剤処方情報分布比較!$N$2:$N$6</c:f>
              <c:numCache>
                <c:formatCode>0.0</c:formatCode>
                <c:ptCount val="5"/>
                <c:pt idx="0">
                  <c:v>10.256410256410255</c:v>
                </c:pt>
                <c:pt idx="1">
                  <c:v>16.809116809116809</c:v>
                </c:pt>
                <c:pt idx="2">
                  <c:v>23.931623931623932</c:v>
                </c:pt>
                <c:pt idx="3">
                  <c:v>40.74074074074074</c:v>
                </c:pt>
                <c:pt idx="4">
                  <c:v>8.26210826210826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62-4EDD-BF2B-4051065EB3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7"/>
        <c:axId val="565536792"/>
        <c:axId val="565537448"/>
      </c:barChart>
      <c:catAx>
        <c:axId val="565536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5537448"/>
        <c:crosses val="autoZero"/>
        <c:auto val="1"/>
        <c:lblAlgn val="ctr"/>
        <c:lblOffset val="100"/>
        <c:noMultiLvlLbl val="0"/>
      </c:catAx>
      <c:valAx>
        <c:axId val="56553744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65536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225568-370B-4C2A-9CC7-5BF5A1814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D38F6E-3E9C-43CB-A54C-4D890305743B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4A49B31-78CA-4337-8BB0-08B5B514E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A5EFD9-FE39-4FBC-9A33-425034541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937B0B-903A-46F0-8C4A-7CCE4655423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8682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3128FF-A9FF-40C4-B0C4-E9C9C0738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70D9B9-ADE5-411B-AD2A-9A23FC9FA3F2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6CD2CA-BEDD-4FC4-8509-FB118F64F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9B7CA2-0CB7-4824-93E0-B1D4C0232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EDFC73-FBA2-4BD8-80A8-D2EE9830D4B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00779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2FFFB3-D34B-48BB-9CA4-B96E379E3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529E12-7DFF-47B8-961D-7281034E941E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69F2526-0662-448A-9C27-5BC5692C9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99090F-7589-44A5-B003-2DDFB1197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371B4-F6C8-4EDF-A06A-C0F20F4DF39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41271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E9AB851-5345-4D4E-B70B-94B9D63FE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492002-7DAE-4FB8-AF8D-2B1DC0E06647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BD68FA7-8B3C-42DD-8332-DAAB8DA0E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840F1B-26B9-46E4-954C-E7FDE4D18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4EE777-AD2B-4474-B630-F14300F32E8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91171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145906-AFFF-4CF6-ADD6-A5AC4EC93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EE1C58-FC98-4680-8E4E-5BB5F1113802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6E19F4-7F58-4275-B724-E560E2419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697957-03FB-415E-99E1-0378884CA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183147-46E7-4180-BA89-E75F8E394DE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51150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83D911B9-1201-4AC4-AB79-781160645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CA1735-FE2B-4F3C-AB66-F9122DD7F918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27B88CA5-2AED-483E-9745-3A9EB34A9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08CE9C14-8816-45C1-82B1-501534157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2708DA-36ED-4E27-AB71-23B1DAE09A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57905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1D2B7B7F-3D21-4C88-954C-2209460E9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B2022D-8056-425B-885F-A3E78176F21A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85F3298C-D2C7-414F-AE28-4E938D4BB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9E2969B4-AC2B-4421-93B9-D4862D320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00A2CB-ABE7-44F1-BA78-F5D72D53C72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4008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C1100945-12A2-4990-8260-8954F06CA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9E6844-0F53-4286-80EA-DC339B048E95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38F9FB20-6609-4C2F-B363-D35650CC5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38D3AB27-64FD-4BFC-8B11-B51932473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44B4A0-F433-4522-B056-7E90B5BBA59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99307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6F690CC1-5B8C-4522-9258-CB9C817F1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9A6964-32C6-447C-8F48-58C15EEB5B21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295A92CB-A414-497E-965A-6D0347828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175E169F-6EB0-4C4B-A33B-DC4AD6435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5F40ED-A329-4DFE-AB10-DB5A604B98A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119678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2D5E03DA-8585-4FBE-BFE8-5A78E6620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CC31BB-E682-4BEB-BE03-BF67D43F0647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F38496D8-15FB-4582-8DA0-3B961CC771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B31033D0-9A66-4A3F-9E0B-9BB61606A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959D5D-09A2-4D73-BC59-C6CE5F5159A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8645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94BEBFEC-D9CD-4D3C-A9CE-8B3F063F5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2189FA-04D1-4714-B69A-CFAC493262E4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699A0C77-0FF2-41E7-8118-989D33360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E9453F25-2E7C-4021-9876-77ED9FDD7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3705EB-3BDA-4F1B-85F0-595EC3A9957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01070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9DAD7F2D-EE3F-4085-97C5-1D49B9FB588A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9E05F935-C885-4E71-BC55-7EF98363A9E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90D1ED-85CA-48B5-A311-2D84BE5DDF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67BA35B-F55F-4C37-842C-7F6AD6CFD5E7}" type="datetimeFigureOut">
              <a:rPr lang="ja-JP" altLang="en-US"/>
              <a:pPr>
                <a:defRPr/>
              </a:pPr>
              <a:t>2018/4/15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D8CE8C-6FFE-4DD0-8A73-B6711BF965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147B2A-2BD8-48E7-BC35-BA8B819855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8DD0E199-4712-4B39-963E-44B03978A12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31">
            <a:extLst>
              <a:ext uri="{FF2B5EF4-FFF2-40B4-BE49-F238E27FC236}">
                <a16:creationId xmlns:a16="http://schemas.microsoft.com/office/drawing/2014/main" id="{0177A75F-67B2-4593-85DC-C078C5DDB3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6000" y="638105"/>
            <a:ext cx="5762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74D1AA2A-D497-4933-826E-0FF7447CC0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966427"/>
              </p:ext>
            </p:extLst>
          </p:nvPr>
        </p:nvGraphicFramePr>
        <p:xfrm>
          <a:off x="2016125" y="981075"/>
          <a:ext cx="9119875" cy="5471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88169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464</TotalTime>
  <Words>1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林和俊</dc:creator>
  <cp:lastModifiedBy>Fujibayashi Kazutoshi</cp:lastModifiedBy>
  <cp:revision>169</cp:revision>
  <dcterms:created xsi:type="dcterms:W3CDTF">2015-07-26T23:57:55Z</dcterms:created>
  <dcterms:modified xsi:type="dcterms:W3CDTF">2018-04-15T01:05:41Z</dcterms:modified>
</cp:coreProperties>
</file>